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12192000" cy="9144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02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4232" autoAdjust="0"/>
    <p:restoredTop sz="94660"/>
  </p:normalViewPr>
  <p:slideViewPr>
    <p:cSldViewPr snapToGrid="0">
      <p:cViewPr varScale="1">
        <p:scale>
          <a:sx n="77" d="100"/>
          <a:sy n="77" d="100"/>
        </p:scale>
        <p:origin x="-690" y="-102"/>
      </p:cViewPr>
      <p:guideLst>
        <p:guide orient="horz" pos="102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8CB7CB-FEBB-4334-8522-FA0D37ABD8ED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57DF26-5A18-4996-9CD9-7A05E92A9A2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66910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657DF26-5A18-4996-9CD9-7A05E92A9A24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206159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914400" y="2840569"/>
            <a:ext cx="103632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828800" y="5181600"/>
            <a:ext cx="85344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8128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6256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4384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2512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0640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8768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6896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65024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8258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01709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839200" y="366188"/>
            <a:ext cx="2743200" cy="780203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609600" y="366188"/>
            <a:ext cx="8026400" cy="780203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60741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263495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63084" y="5875867"/>
            <a:ext cx="10363200" cy="1816100"/>
          </a:xfrm>
        </p:spPr>
        <p:txBody>
          <a:bodyPr anchor="t"/>
          <a:lstStyle>
            <a:lvl1pPr algn="l">
              <a:defRPr sz="7111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63084" y="3875621"/>
            <a:ext cx="10363200" cy="2000249"/>
          </a:xfrm>
        </p:spPr>
        <p:txBody>
          <a:bodyPr anchor="b"/>
          <a:lstStyle>
            <a:lvl1pPr marL="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1pPr>
            <a:lvl2pPr marL="81281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13493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609600" y="2133604"/>
            <a:ext cx="5384800" cy="6034617"/>
          </a:xfrm>
        </p:spPr>
        <p:txBody>
          <a:bodyPr/>
          <a:lstStyle>
            <a:lvl1pPr>
              <a:defRPr sz="4978"/>
            </a:lvl1pPr>
            <a:lvl2pPr>
              <a:defRPr sz="4267"/>
            </a:lvl2pPr>
            <a:lvl3pPr>
              <a:defRPr sz="3556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97600" y="2133604"/>
            <a:ext cx="5384800" cy="6034617"/>
          </a:xfrm>
        </p:spPr>
        <p:txBody>
          <a:bodyPr/>
          <a:lstStyle>
            <a:lvl1pPr>
              <a:defRPr sz="4978"/>
            </a:lvl1pPr>
            <a:lvl2pPr>
              <a:defRPr sz="4267"/>
            </a:lvl2pPr>
            <a:lvl3pPr>
              <a:defRPr sz="3556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85780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3" y="2046817"/>
            <a:ext cx="5386917" cy="853016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09603" y="2899833"/>
            <a:ext cx="5386917" cy="5268384"/>
          </a:xfrm>
        </p:spPr>
        <p:txBody>
          <a:bodyPr/>
          <a:lstStyle>
            <a:lvl1pPr>
              <a:defRPr sz="4267"/>
            </a:lvl1pPr>
            <a:lvl2pPr>
              <a:defRPr sz="3556"/>
            </a:lvl2pPr>
            <a:lvl3pPr>
              <a:defRPr sz="3200"/>
            </a:lvl3pPr>
            <a:lvl4pPr>
              <a:defRPr sz="2844"/>
            </a:lvl4pPr>
            <a:lvl5pPr>
              <a:defRPr sz="2844"/>
            </a:lvl5pPr>
            <a:lvl6pPr>
              <a:defRPr sz="2844"/>
            </a:lvl6pPr>
            <a:lvl7pPr>
              <a:defRPr sz="2844"/>
            </a:lvl7pPr>
            <a:lvl8pPr>
              <a:defRPr sz="2844"/>
            </a:lvl8pPr>
            <a:lvl9pPr>
              <a:defRPr sz="2844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93370" y="2046817"/>
            <a:ext cx="5389033" cy="853016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93370" y="2899833"/>
            <a:ext cx="5389033" cy="5268384"/>
          </a:xfrm>
        </p:spPr>
        <p:txBody>
          <a:bodyPr/>
          <a:lstStyle>
            <a:lvl1pPr>
              <a:defRPr sz="4267"/>
            </a:lvl1pPr>
            <a:lvl2pPr>
              <a:defRPr sz="3556"/>
            </a:lvl2pPr>
            <a:lvl3pPr>
              <a:defRPr sz="3200"/>
            </a:lvl3pPr>
            <a:lvl4pPr>
              <a:defRPr sz="2844"/>
            </a:lvl4pPr>
            <a:lvl5pPr>
              <a:defRPr sz="2844"/>
            </a:lvl5pPr>
            <a:lvl6pPr>
              <a:defRPr sz="2844"/>
            </a:lvl6pPr>
            <a:lvl7pPr>
              <a:defRPr sz="2844"/>
            </a:lvl7pPr>
            <a:lvl8pPr>
              <a:defRPr sz="2844"/>
            </a:lvl8pPr>
            <a:lvl9pPr>
              <a:defRPr sz="2844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659522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07597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5596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1" y="364067"/>
            <a:ext cx="4011084" cy="1549400"/>
          </a:xfrm>
        </p:spPr>
        <p:txBody>
          <a:bodyPr anchor="b"/>
          <a:lstStyle>
            <a:lvl1pPr algn="l">
              <a:defRPr sz="3556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766733" y="364070"/>
            <a:ext cx="6815668" cy="7804151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09601" y="1913470"/>
            <a:ext cx="4011084" cy="6254751"/>
          </a:xfrm>
        </p:spPr>
        <p:txBody>
          <a:bodyPr/>
          <a:lstStyle>
            <a:lvl1pPr marL="0" indent="0">
              <a:buNone/>
              <a:defRPr sz="2489"/>
            </a:lvl1pPr>
            <a:lvl2pPr marL="812810" indent="0">
              <a:buNone/>
              <a:defRPr sz="2133"/>
            </a:lvl2pPr>
            <a:lvl3pPr marL="1625620" indent="0">
              <a:buNone/>
              <a:defRPr sz="1778"/>
            </a:lvl3pPr>
            <a:lvl4pPr marL="2438430" indent="0">
              <a:buNone/>
              <a:defRPr sz="1600"/>
            </a:lvl4pPr>
            <a:lvl5pPr marL="3251241" indent="0">
              <a:buNone/>
              <a:defRPr sz="1600"/>
            </a:lvl5pPr>
            <a:lvl6pPr marL="4064051" indent="0">
              <a:buNone/>
              <a:defRPr sz="1600"/>
            </a:lvl6pPr>
            <a:lvl7pPr marL="4876861" indent="0">
              <a:buNone/>
              <a:defRPr sz="1600"/>
            </a:lvl7pPr>
            <a:lvl8pPr marL="5689671" indent="0">
              <a:buNone/>
              <a:defRPr sz="1600"/>
            </a:lvl8pPr>
            <a:lvl9pPr marL="6502481" indent="0">
              <a:buNone/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65922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9717" y="6400803"/>
            <a:ext cx="7315200" cy="755651"/>
          </a:xfrm>
        </p:spPr>
        <p:txBody>
          <a:bodyPr anchor="b"/>
          <a:lstStyle>
            <a:lvl1pPr algn="l">
              <a:defRPr sz="3556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89717" y="817033"/>
            <a:ext cx="7315200" cy="5486400"/>
          </a:xfrm>
        </p:spPr>
        <p:txBody>
          <a:bodyPr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89717" y="7156454"/>
            <a:ext cx="7315200" cy="1073149"/>
          </a:xfrm>
        </p:spPr>
        <p:txBody>
          <a:bodyPr/>
          <a:lstStyle>
            <a:lvl1pPr marL="0" indent="0">
              <a:buNone/>
              <a:defRPr sz="2489"/>
            </a:lvl1pPr>
            <a:lvl2pPr marL="812810" indent="0">
              <a:buNone/>
              <a:defRPr sz="2133"/>
            </a:lvl2pPr>
            <a:lvl3pPr marL="1625620" indent="0">
              <a:buNone/>
              <a:defRPr sz="1778"/>
            </a:lvl3pPr>
            <a:lvl4pPr marL="2438430" indent="0">
              <a:buNone/>
              <a:defRPr sz="1600"/>
            </a:lvl4pPr>
            <a:lvl5pPr marL="3251241" indent="0">
              <a:buNone/>
              <a:defRPr sz="1600"/>
            </a:lvl5pPr>
            <a:lvl6pPr marL="4064051" indent="0">
              <a:buNone/>
              <a:defRPr sz="1600"/>
            </a:lvl6pPr>
            <a:lvl7pPr marL="4876861" indent="0">
              <a:buNone/>
              <a:defRPr sz="1600"/>
            </a:lvl7pPr>
            <a:lvl8pPr marL="5689671" indent="0">
              <a:buNone/>
              <a:defRPr sz="1600"/>
            </a:lvl8pPr>
            <a:lvl9pPr marL="6502481" indent="0">
              <a:buNone/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94534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609600" y="366184"/>
            <a:ext cx="109728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0" y="2133604"/>
            <a:ext cx="109728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609600" y="8475137"/>
            <a:ext cx="284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165600" y="8475137"/>
            <a:ext cx="3860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737600" y="8475137"/>
            <a:ext cx="284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81071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625620" rtl="0" eaLnBrk="1" latinLnBrk="1" hangingPunct="1"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09608" indent="-609608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5689" kern="1200">
          <a:solidFill>
            <a:schemeClr val="tx1"/>
          </a:solidFill>
          <a:latin typeface="+mn-lt"/>
          <a:ea typeface="+mn-ea"/>
          <a:cs typeface="+mn-cs"/>
        </a:defRPr>
      </a:lvl1pPr>
      <a:lvl2pPr marL="1320817" indent="-508006" algn="l" defTabSz="1625620" rtl="0" eaLnBrk="1" latinLnBrk="1" hangingPunct="1">
        <a:spcBef>
          <a:spcPct val="20000"/>
        </a:spcBef>
        <a:buFont typeface="Arial" panose="020B0604020202020204" pitchFamily="34" charset="0"/>
        <a:buChar char="–"/>
        <a:defRPr sz="4978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–"/>
        <a:defRPr sz="3556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»"/>
        <a:defRPr sz="3556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-3324" y="583270"/>
            <a:ext cx="12189883" cy="420610"/>
          </a:xfrm>
          <a:prstGeom prst="rect">
            <a:avLst/>
          </a:prstGeom>
        </p:spPr>
        <p:txBody>
          <a:bodyPr wrap="square" lIns="142224" tIns="71111" rIns="142224" bIns="71111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2. Summary of statistical data for whole-transcriptome sequencing data used in this study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표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93349318"/>
              </p:ext>
            </p:extLst>
          </p:nvPr>
        </p:nvGraphicFramePr>
        <p:xfrm>
          <a:off x="158663" y="1018571"/>
          <a:ext cx="12033337" cy="7543351"/>
        </p:xfrm>
        <a:graphic>
          <a:graphicData uri="http://schemas.openxmlformats.org/drawingml/2006/table">
            <a:tbl>
              <a:tblPr/>
              <a:tblGrid>
                <a:gridCol w="831937"/>
                <a:gridCol w="1341120"/>
                <a:gridCol w="1554480"/>
                <a:gridCol w="1188720"/>
                <a:gridCol w="762000"/>
                <a:gridCol w="1584960"/>
                <a:gridCol w="1493520"/>
                <a:gridCol w="1889760"/>
                <a:gridCol w="1386840"/>
              </a:tblGrid>
              <a:tr h="460974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　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lean reads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lean bases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% of &gt;=Q20 bases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C(%)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apped reads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ultiple aligned reads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apping rate (%)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ean depth (X)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53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C1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4,696,030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,622,642,700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6.57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7.16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6,681,339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,401,850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0.54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3.98 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353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C2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9,133,504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,122,015,360 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7.83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7.95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2,135,985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,311,894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1.16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7.81 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353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C3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8,213,186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,039,186,740 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6.98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7.46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0,656,940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,377,946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0.34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6.79 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353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C4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8,064,066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,025,765,940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6.24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8.69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1,277,081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,737,355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1.31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6.62 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353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C5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9,467,878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,152,109,020 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7.09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8.47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1,310,938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,696,601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9.74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8.18 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353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C1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5,362,096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,682,588,640 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7.51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6.59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6,505,385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,683,986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9.62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4.72 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353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C2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7,081,300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,837,317,000 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5.95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7.05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7,818,722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,418,094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9.36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6.63 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353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C3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8,190,918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,037,182,620 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6.87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7.40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1,142,466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,163,228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0.99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6.77 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353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C4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9,659,924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</a:t>
                      </a:r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,169,393,160 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6.56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8.28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1,366,110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,403,497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9.59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8.40 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353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C5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7,973,588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,017,622,920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5.67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8.42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0,797,037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,873,081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0.80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6.52 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353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LM1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8,479,512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,063,156,080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7.23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8.16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1,395,615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,996,306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0.97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7.09 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353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LM2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8,491,278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,064,215,020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5.64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8.31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2,050,565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,680,089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1.79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7.10 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353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LM3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8,169,766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,035,278,940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6.77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7.27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1,073,590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,369,043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0.92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6.74 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353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LM4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8,108,880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,029,799,200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6.84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8.70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1,879,820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,534,461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2.03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6.67 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353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LM5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6,645,816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,798,123,440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5.98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4.92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7,410,905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,441,877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9.34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6.15 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353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L1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9,048,108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,114,329,720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7.71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7.89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2,224,998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,546,131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1.37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7.72 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353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L2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3,962,882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,556,659,380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7.20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7.68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6,647,669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,320,086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1.29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3.17 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353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L3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5,686,218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,711,759,620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7.13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5.97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6,136,282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3,243,985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8.85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5.08 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353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L4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7,288,762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,055,988,580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7.60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7.48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9,314,952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,280,187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8.15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4.67 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353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NL5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4,443,810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,599,942,900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7.68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6.50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5,607,921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,908,875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9.54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3.70 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3531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verage</a:t>
                      </a: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0,408,376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,236,753,849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6.85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7.52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2,671,716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2,319,429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0.38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9.23 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4140" marR="14140" marT="141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26400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70</TotalTime>
  <Words>237</Words>
  <Application>Microsoft Office PowerPoint</Application>
  <PresentationFormat>Custom</PresentationFormat>
  <Paragraphs>20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 Author</dc:creator>
  <cp:lastModifiedBy>Real, Francis Frank</cp:lastModifiedBy>
  <cp:revision>55</cp:revision>
  <dcterms:created xsi:type="dcterms:W3CDTF">2015-06-22T23:51:12Z</dcterms:created>
  <dcterms:modified xsi:type="dcterms:W3CDTF">2016-07-26T03:43:42Z</dcterms:modified>
</cp:coreProperties>
</file>